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AC8647-8362-4A68-998E-A0DB9C28E5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93B471-5566-4A39-8D87-3C90F26B70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2D487-EBF4-4F25-B53D-470FD372467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C124E-937F-41CB-8C04-DDC29827B9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B8A993-1D20-4E09-B078-721216C166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1BF5A-F491-4A6B-8C2C-30B62D3504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FDE23-9FDB-4178-AD62-04A3659497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23C9E-D6DD-4659-8A47-16F6559416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9187A3-6EE2-433F-A76B-FD1D4F225E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FB4DB2-A2AE-4B1A-AE36-84124BEEEA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821F9-F390-4635-9B30-0C3060EA78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5CC54-04A8-4BDE-9D6B-1B80966C2D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E65F1E-0256-4100-BA89-8320CF418C5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96120" y="87480"/>
            <a:ext cx="5694480" cy="368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 Figure 1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:  Flow Diagram of laboratory analyses perform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4"/>
          <p:cNvSpPr/>
          <p:nvPr/>
        </p:nvSpPr>
        <p:spPr>
          <a:xfrm>
            <a:off x="1905120" y="696960"/>
            <a:ext cx="502920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30 ESCC cases  with matched tumor/normal tissu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3048120" y="1600200"/>
            <a:ext cx="2743200" cy="140436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D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ffymetrix 500K SNP arr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500,000 SNP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iallelic loss in 77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(Table 1 &amp; Fig 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533520" y="3581280"/>
            <a:ext cx="3124080" cy="140436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mR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ffymetrix U133A 2.0 arr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14,500 gene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RNA data on 52 (of 77)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(S Table 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8"/>
          <p:cNvSpPr/>
          <p:nvPr/>
        </p:nvSpPr>
        <p:spPr>
          <a:xfrm>
            <a:off x="5257800" y="4267080"/>
            <a:ext cx="3733920" cy="140436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miR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BI TaqMan low density arr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664 miRNAs, 396 with T/N signal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60 miRNAs targeted 32 (of 52)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(S Table 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380880" y="5410080"/>
            <a:ext cx="3657600" cy="140436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miRN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BI TaqMan low density arr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664 miRNAs, 396 with T/N signal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70 miRNAs targeted 35 (of 52)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(S Table 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7" name="Straight Arrow Connector 11"/>
          <p:cNvCxnSpPr/>
          <p:nvPr/>
        </p:nvCxnSpPr>
        <p:spPr>
          <a:xfrm flipH="1">
            <a:off x="3733560" y="3200040"/>
            <a:ext cx="457920" cy="22932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8" name="Straight Arrow Connector 21"/>
          <p:cNvCxnSpPr/>
          <p:nvPr/>
        </p:nvCxnSpPr>
        <p:spPr>
          <a:xfrm>
            <a:off x="2133360" y="5028840"/>
            <a:ext cx="1080" cy="30564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9" name="Straight Arrow Connector 23"/>
          <p:cNvCxnSpPr/>
          <p:nvPr/>
        </p:nvCxnSpPr>
        <p:spPr>
          <a:xfrm>
            <a:off x="4419360" y="1143000"/>
            <a:ext cx="1080" cy="38160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0" name="Straight Arrow Connector 25"/>
          <p:cNvCxnSpPr/>
          <p:nvPr/>
        </p:nvCxnSpPr>
        <p:spPr>
          <a:xfrm flipV="1">
            <a:off x="4343400" y="5790960"/>
            <a:ext cx="381600" cy="30528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1" name="Straight Arrow Connector 15"/>
          <p:cNvCxnSpPr/>
          <p:nvPr/>
        </p:nvCxnSpPr>
        <p:spPr>
          <a:xfrm>
            <a:off x="4876920" y="3200040"/>
            <a:ext cx="457920" cy="30564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6-19T21:05:32Z</dcterms:created>
  <dc:creator>Taylor, Phil R. (NIH/NCI)</dc:creator>
  <dc:description/>
  <dc:language>en-US</dc:language>
  <cp:lastModifiedBy>Taylor, Phil R. (NIH/NCI) </cp:lastModifiedBy>
  <dcterms:modified xsi:type="dcterms:W3CDTF">2015-06-22T20:01:01Z</dcterms:modified>
  <cp:revision>10</cp:revision>
  <dc:subject/>
  <dc:title>Slide 1</dc:title>
</cp:coreProperties>
</file>